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DCF75A-2121-4F74-8E67-266D72506C9B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2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A4D414-C880-440B-8A18-99884518B7CD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B1E7B5-1AFB-4360-9EAB-C32A044C63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80D433-C75D-4AE7-A630-2E18729059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D7B2C4-80F0-4638-A5B6-CFDA394F4E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58BD1E-F8AB-4773-8A6E-75C33BF04F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FA284-C8E5-4ADA-B87C-D44BCEF444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A26AC-AD72-4065-992E-265CD39EA4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12179-1F77-4D03-A954-9B53B949B2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8A1435-4E8F-434E-8EA2-E4C58DF188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88735-AA27-4992-A323-30A9D28B54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80E51-55B9-4C1F-A6C3-06057A363B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16183-19DD-4EF3-8E28-90B817AD89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E459C-BDBA-46A7-A0E3-9C3B8A3E51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19D588-447D-4C33-8328-1FA9D61E7962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F:\油料所工作\20180706SS.tif"/>
          <p:cNvPicPr/>
          <p:nvPr/>
        </p:nvPicPr>
        <p:blipFill>
          <a:blip r:embed="rId1"/>
          <a:stretch/>
        </p:blipFill>
        <p:spPr>
          <a:xfrm>
            <a:off x="642960" y="571680"/>
            <a:ext cx="2158920" cy="2604960"/>
          </a:xfrm>
          <a:prstGeom prst="rect">
            <a:avLst/>
          </a:prstGeom>
          <a:ln w="0">
            <a:noFill/>
          </a:ln>
        </p:spPr>
      </p:pic>
      <p:sp>
        <p:nvSpPr>
          <p:cNvPr id="49" name="TextBox 4"/>
          <p:cNvSpPr/>
          <p:nvPr/>
        </p:nvSpPr>
        <p:spPr>
          <a:xfrm>
            <a:off x="3803760" y="1774800"/>
            <a:ext cx="16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S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3" descr="F:\油料所工作\20180706SUT.tif"/>
          <p:cNvPicPr/>
          <p:nvPr/>
        </p:nvPicPr>
        <p:blipFill>
          <a:blip r:embed="rId2"/>
          <a:stretch/>
        </p:blipFill>
        <p:spPr>
          <a:xfrm>
            <a:off x="636480" y="3211560"/>
            <a:ext cx="2160720" cy="958680"/>
          </a:xfrm>
          <a:prstGeom prst="rect">
            <a:avLst/>
          </a:prstGeom>
          <a:ln w="0">
            <a:noFill/>
          </a:ln>
        </p:spPr>
      </p:pic>
      <p:sp>
        <p:nvSpPr>
          <p:cNvPr id="51" name="TextBox 6"/>
          <p:cNvSpPr/>
          <p:nvPr/>
        </p:nvSpPr>
        <p:spPr>
          <a:xfrm>
            <a:off x="3794040" y="3578400"/>
            <a:ext cx="114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SU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4" descr="F:\油料所工作\20180706STP.tif"/>
          <p:cNvPicPr/>
          <p:nvPr/>
        </p:nvPicPr>
        <p:blipFill>
          <a:blip r:embed="rId3"/>
          <a:stretch/>
        </p:blipFill>
        <p:spPr>
          <a:xfrm>
            <a:off x="639720" y="4226040"/>
            <a:ext cx="2160720" cy="325440"/>
          </a:xfrm>
          <a:prstGeom prst="rect">
            <a:avLst/>
          </a:prstGeom>
          <a:ln w="0">
            <a:noFill/>
          </a:ln>
        </p:spPr>
      </p:pic>
      <p:sp>
        <p:nvSpPr>
          <p:cNvPr id="53" name="TextBox 8"/>
          <p:cNvSpPr/>
          <p:nvPr/>
        </p:nvSpPr>
        <p:spPr>
          <a:xfrm>
            <a:off x="3801960" y="4286160"/>
            <a:ext cx="114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S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5" descr="F:\油料所工作\20180706ERD6.tif"/>
          <p:cNvPicPr/>
          <p:nvPr/>
        </p:nvPicPr>
        <p:blipFill>
          <a:blip r:embed="rId4"/>
          <a:stretch/>
        </p:blipFill>
        <p:spPr>
          <a:xfrm>
            <a:off x="623880" y="4565520"/>
            <a:ext cx="2160720" cy="132732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6" descr="F:\油料所工作\20180706SWEET.tif"/>
          <p:cNvPicPr/>
          <p:nvPr/>
        </p:nvPicPr>
        <p:blipFill>
          <a:blip r:embed="rId5"/>
          <a:stretch/>
        </p:blipFill>
        <p:spPr>
          <a:xfrm>
            <a:off x="628560" y="5902200"/>
            <a:ext cx="2160720" cy="1764000"/>
          </a:xfrm>
          <a:prstGeom prst="rect">
            <a:avLst/>
          </a:prstGeom>
          <a:ln w="0">
            <a:noFill/>
          </a:ln>
        </p:spPr>
      </p:pic>
      <p:sp>
        <p:nvSpPr>
          <p:cNvPr id="56" name="TextBox 12"/>
          <p:cNvSpPr/>
          <p:nvPr/>
        </p:nvSpPr>
        <p:spPr>
          <a:xfrm>
            <a:off x="3780000" y="5091120"/>
            <a:ext cx="714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ER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3"/>
          <p:cNvSpPr/>
          <p:nvPr/>
        </p:nvSpPr>
        <p:spPr>
          <a:xfrm>
            <a:off x="3778200" y="6673680"/>
            <a:ext cx="928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SWEE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矩形 14"/>
          <p:cNvSpPr/>
          <p:nvPr/>
        </p:nvSpPr>
        <p:spPr>
          <a:xfrm>
            <a:off x="2728080" y="552600"/>
            <a:ext cx="75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PGB0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矩形 15"/>
          <p:cNvSpPr/>
          <p:nvPr/>
        </p:nvSpPr>
        <p:spPr>
          <a:xfrm>
            <a:off x="2730600" y="684360"/>
            <a:ext cx="72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KJ31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矩形 16"/>
          <p:cNvSpPr/>
          <p:nvPr/>
        </p:nvSpPr>
        <p:spPr>
          <a:xfrm>
            <a:off x="2732760" y="811080"/>
            <a:ext cx="73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P91L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矩形 17"/>
          <p:cNvSpPr/>
          <p:nvPr/>
        </p:nvSpPr>
        <p:spPr>
          <a:xfrm>
            <a:off x="2726640" y="942840"/>
            <a:ext cx="75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Q29M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矩形 18"/>
          <p:cNvSpPr/>
          <p:nvPr/>
        </p:nvSpPr>
        <p:spPr>
          <a:xfrm>
            <a:off x="2721240" y="1069920"/>
            <a:ext cx="72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NY16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矩形 19"/>
          <p:cNvSpPr/>
          <p:nvPr/>
        </p:nvSpPr>
        <p:spPr>
          <a:xfrm>
            <a:off x="2729160" y="120024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YD4H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矩形 20"/>
          <p:cNvSpPr/>
          <p:nvPr/>
        </p:nvSpPr>
        <p:spPr>
          <a:xfrm>
            <a:off x="2715120" y="1328760"/>
            <a:ext cx="7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G1NK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矩形 21"/>
          <p:cNvSpPr/>
          <p:nvPr/>
        </p:nvSpPr>
        <p:spPr>
          <a:xfrm>
            <a:off x="2718000" y="1449360"/>
            <a:ext cx="81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M5S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矩形 22"/>
          <p:cNvSpPr/>
          <p:nvPr/>
        </p:nvSpPr>
        <p:spPr>
          <a:xfrm>
            <a:off x="2727360" y="1577880"/>
            <a:ext cx="72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NY16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矩形 23"/>
          <p:cNvSpPr/>
          <p:nvPr/>
        </p:nvSpPr>
        <p:spPr>
          <a:xfrm>
            <a:off x="2747520" y="1704960"/>
            <a:ext cx="73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BXI1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矩形 24"/>
          <p:cNvSpPr/>
          <p:nvPr/>
        </p:nvSpPr>
        <p:spPr>
          <a:xfrm>
            <a:off x="2732040" y="1843200"/>
            <a:ext cx="7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51VQ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矩形 25"/>
          <p:cNvSpPr/>
          <p:nvPr/>
        </p:nvSpPr>
        <p:spPr>
          <a:xfrm>
            <a:off x="2736000" y="1986120"/>
            <a:ext cx="744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M1B5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矩形 26"/>
          <p:cNvSpPr/>
          <p:nvPr/>
        </p:nvSpPr>
        <p:spPr>
          <a:xfrm>
            <a:off x="2727000" y="2095560"/>
            <a:ext cx="73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30W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矩形 27"/>
          <p:cNvSpPr/>
          <p:nvPr/>
        </p:nvSpPr>
        <p:spPr>
          <a:xfrm>
            <a:off x="2716920" y="2224080"/>
            <a:ext cx="781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L0AD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矩形 28"/>
          <p:cNvSpPr/>
          <p:nvPr/>
        </p:nvSpPr>
        <p:spPr>
          <a:xfrm>
            <a:off x="2723400" y="2344680"/>
            <a:ext cx="75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HLR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矩形 29"/>
          <p:cNvSpPr/>
          <p:nvPr/>
        </p:nvSpPr>
        <p:spPr>
          <a:xfrm>
            <a:off x="2729520" y="247032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A249Q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矩形 30"/>
          <p:cNvSpPr/>
          <p:nvPr/>
        </p:nvSpPr>
        <p:spPr>
          <a:xfrm>
            <a:off x="2746440" y="2600280"/>
            <a:ext cx="7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FPQ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矩形 31"/>
          <p:cNvSpPr/>
          <p:nvPr/>
        </p:nvSpPr>
        <p:spPr>
          <a:xfrm>
            <a:off x="2727360" y="273852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PD37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矩形 32"/>
          <p:cNvSpPr/>
          <p:nvPr/>
        </p:nvSpPr>
        <p:spPr>
          <a:xfrm>
            <a:off x="2728800" y="2881440"/>
            <a:ext cx="7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EG0W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矩形 33"/>
          <p:cNvSpPr/>
          <p:nvPr/>
        </p:nvSpPr>
        <p:spPr>
          <a:xfrm>
            <a:off x="2731320" y="2990880"/>
            <a:ext cx="71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7T75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矩形 34"/>
          <p:cNvSpPr/>
          <p:nvPr/>
        </p:nvSpPr>
        <p:spPr>
          <a:xfrm>
            <a:off x="2737080" y="3195720"/>
            <a:ext cx="72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L3BR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矩形 35"/>
          <p:cNvSpPr/>
          <p:nvPr/>
        </p:nvSpPr>
        <p:spPr>
          <a:xfrm>
            <a:off x="2742120" y="3316320"/>
            <a:ext cx="7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KU5Z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矩形 36"/>
          <p:cNvSpPr/>
          <p:nvPr/>
        </p:nvSpPr>
        <p:spPr>
          <a:xfrm>
            <a:off x="2724120" y="3452760"/>
            <a:ext cx="7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0H2V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矩形 37"/>
          <p:cNvSpPr/>
          <p:nvPr/>
        </p:nvSpPr>
        <p:spPr>
          <a:xfrm>
            <a:off x="2728080" y="3573360"/>
            <a:ext cx="77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53MM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矩形 38"/>
          <p:cNvSpPr/>
          <p:nvPr/>
        </p:nvSpPr>
        <p:spPr>
          <a:xfrm>
            <a:off x="2725920" y="370368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SQ8X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矩形 39"/>
          <p:cNvSpPr/>
          <p:nvPr/>
        </p:nvSpPr>
        <p:spPr>
          <a:xfrm>
            <a:off x="2725560" y="3824280"/>
            <a:ext cx="7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QA3D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矩形 40"/>
          <p:cNvSpPr/>
          <p:nvPr/>
        </p:nvSpPr>
        <p:spPr>
          <a:xfrm>
            <a:off x="2715480" y="3965400"/>
            <a:ext cx="77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M7BX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矩形 41"/>
          <p:cNvSpPr/>
          <p:nvPr/>
        </p:nvSpPr>
        <p:spPr>
          <a:xfrm>
            <a:off x="2737080" y="4195800"/>
            <a:ext cx="72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QL0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矩形 42"/>
          <p:cNvSpPr/>
          <p:nvPr/>
        </p:nvSpPr>
        <p:spPr>
          <a:xfrm>
            <a:off x="2734560" y="4348080"/>
            <a:ext cx="782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95DD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矩形 43"/>
          <p:cNvSpPr/>
          <p:nvPr/>
        </p:nvSpPr>
        <p:spPr>
          <a:xfrm>
            <a:off x="2723040" y="451800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A5JK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矩形 44"/>
          <p:cNvSpPr/>
          <p:nvPr/>
        </p:nvSpPr>
        <p:spPr>
          <a:xfrm>
            <a:off x="2726280" y="4653000"/>
            <a:ext cx="73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C4SE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矩形 45"/>
          <p:cNvSpPr/>
          <p:nvPr/>
        </p:nvSpPr>
        <p:spPr>
          <a:xfrm>
            <a:off x="2721240" y="4788000"/>
            <a:ext cx="803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DQM3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矩形 46"/>
          <p:cNvSpPr/>
          <p:nvPr/>
        </p:nvSpPr>
        <p:spPr>
          <a:xfrm>
            <a:off x="2726640" y="4917960"/>
            <a:ext cx="71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J68A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矩形 47"/>
          <p:cNvSpPr/>
          <p:nvPr/>
        </p:nvSpPr>
        <p:spPr>
          <a:xfrm>
            <a:off x="2717280" y="5052960"/>
            <a:ext cx="72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N5T9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矩形 48"/>
          <p:cNvSpPr/>
          <p:nvPr/>
        </p:nvSpPr>
        <p:spPr>
          <a:xfrm>
            <a:off x="2721600" y="518796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MI3U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矩形 49"/>
          <p:cNvSpPr/>
          <p:nvPr/>
        </p:nvSpPr>
        <p:spPr>
          <a:xfrm>
            <a:off x="2717280" y="5300640"/>
            <a:ext cx="720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1X0L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矩形 50"/>
          <p:cNvSpPr/>
          <p:nvPr/>
        </p:nvSpPr>
        <p:spPr>
          <a:xfrm>
            <a:off x="2715480" y="5435640"/>
            <a:ext cx="744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S0VR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矩形 51"/>
          <p:cNvSpPr/>
          <p:nvPr/>
        </p:nvSpPr>
        <p:spPr>
          <a:xfrm>
            <a:off x="2724120" y="5570640"/>
            <a:ext cx="7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3RL8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矩形 52"/>
          <p:cNvSpPr/>
          <p:nvPr/>
        </p:nvSpPr>
        <p:spPr>
          <a:xfrm>
            <a:off x="2726640" y="5708520"/>
            <a:ext cx="76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HL47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矩形 53"/>
          <p:cNvSpPr/>
          <p:nvPr/>
        </p:nvSpPr>
        <p:spPr>
          <a:xfrm>
            <a:off x="2715840" y="5886360"/>
            <a:ext cx="76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UZC9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矩形 54"/>
          <p:cNvSpPr/>
          <p:nvPr/>
        </p:nvSpPr>
        <p:spPr>
          <a:xfrm>
            <a:off x="2724120" y="6021360"/>
            <a:ext cx="70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AI6C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矩形 55"/>
          <p:cNvSpPr/>
          <p:nvPr/>
        </p:nvSpPr>
        <p:spPr>
          <a:xfrm>
            <a:off x="2723760" y="6165720"/>
            <a:ext cx="76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42GV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矩形 56"/>
          <p:cNvSpPr/>
          <p:nvPr/>
        </p:nvSpPr>
        <p:spPr>
          <a:xfrm>
            <a:off x="2720160" y="6300720"/>
            <a:ext cx="750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1W4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矩形 57"/>
          <p:cNvSpPr/>
          <p:nvPr/>
        </p:nvSpPr>
        <p:spPr>
          <a:xfrm>
            <a:off x="2723400" y="6435720"/>
            <a:ext cx="75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LSW2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矩形 58"/>
          <p:cNvSpPr/>
          <p:nvPr/>
        </p:nvSpPr>
        <p:spPr>
          <a:xfrm>
            <a:off x="2710080" y="656100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ZB8C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矩形 59"/>
          <p:cNvSpPr/>
          <p:nvPr/>
        </p:nvSpPr>
        <p:spPr>
          <a:xfrm>
            <a:off x="2718720" y="6673680"/>
            <a:ext cx="75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REH1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矩形 60"/>
          <p:cNvSpPr/>
          <p:nvPr/>
        </p:nvSpPr>
        <p:spPr>
          <a:xfrm>
            <a:off x="2718000" y="679752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T2X2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矩形 61"/>
          <p:cNvSpPr/>
          <p:nvPr/>
        </p:nvSpPr>
        <p:spPr>
          <a:xfrm>
            <a:off x="2715120" y="6943680"/>
            <a:ext cx="73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793G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矩形 62"/>
          <p:cNvSpPr/>
          <p:nvPr/>
        </p:nvSpPr>
        <p:spPr>
          <a:xfrm>
            <a:off x="2721600" y="7067520"/>
            <a:ext cx="7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7QQ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矩形 63"/>
          <p:cNvSpPr/>
          <p:nvPr/>
        </p:nvSpPr>
        <p:spPr>
          <a:xfrm>
            <a:off x="2709000" y="7196040"/>
            <a:ext cx="75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HBL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矩形 64"/>
          <p:cNvSpPr/>
          <p:nvPr/>
        </p:nvSpPr>
        <p:spPr>
          <a:xfrm>
            <a:off x="2694600" y="7342200"/>
            <a:ext cx="69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J86Y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矩形 65"/>
          <p:cNvSpPr/>
          <p:nvPr/>
        </p:nvSpPr>
        <p:spPr>
          <a:xfrm>
            <a:off x="2715840" y="7466040"/>
            <a:ext cx="74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0C27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右大括号 66"/>
          <p:cNvSpPr/>
          <p:nvPr/>
        </p:nvSpPr>
        <p:spPr>
          <a:xfrm>
            <a:off x="3714840" y="600120"/>
            <a:ext cx="142920" cy="2519280"/>
          </a:xfrm>
          <a:custGeom>
            <a:avLst/>
            <a:gdLst>
              <a:gd name="textAreaLeft" fmla="*/ 0 w 142920"/>
              <a:gd name="textAreaRight" fmla="*/ 51480 w 142920"/>
              <a:gd name="textAreaTop" fmla="*/ 3600 h 2519280"/>
              <a:gd name="textAreaBottom" fmla="*/ 2515680 h 2519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1"/>
                  <a:pt x="10800" y="102"/>
                </a:cubicBezTo>
                <a:lnTo>
                  <a:pt x="10800" y="10698"/>
                </a:lnTo>
                <a:cubicBezTo>
                  <a:pt x="10800" y="10749"/>
                  <a:pt x="16200" y="10800"/>
                  <a:pt x="21600" y="10800"/>
                </a:cubicBezTo>
                <a:cubicBezTo>
                  <a:pt x="16200" y="10800"/>
                  <a:pt x="10800" y="10851"/>
                  <a:pt x="10800" y="10902"/>
                </a:cubicBezTo>
                <a:lnTo>
                  <a:pt x="10800" y="21498"/>
                </a:lnTo>
                <a:cubicBezTo>
                  <a:pt x="10800" y="21549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右大括号 67"/>
          <p:cNvSpPr/>
          <p:nvPr/>
        </p:nvSpPr>
        <p:spPr>
          <a:xfrm>
            <a:off x="3703680" y="3224160"/>
            <a:ext cx="142920" cy="882720"/>
          </a:xfrm>
          <a:custGeom>
            <a:avLst/>
            <a:gdLst>
              <a:gd name="textAreaLeft" fmla="*/ 0 w 142920"/>
              <a:gd name="textAreaRight" fmla="*/ 51480 w 142920"/>
              <a:gd name="textAreaTop" fmla="*/ 3600 h 882720"/>
              <a:gd name="textAreaBottom" fmla="*/ 879120 h 8827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46"/>
                  <a:pt x="10800" y="291"/>
                </a:cubicBezTo>
                <a:lnTo>
                  <a:pt x="10800" y="10509"/>
                </a:lnTo>
                <a:cubicBezTo>
                  <a:pt x="10800" y="10655"/>
                  <a:pt x="16200" y="10800"/>
                  <a:pt x="21600" y="10800"/>
                </a:cubicBezTo>
                <a:cubicBezTo>
                  <a:pt x="16200" y="10800"/>
                  <a:pt x="10800" y="10946"/>
                  <a:pt x="10800" y="11091"/>
                </a:cubicBezTo>
                <a:lnTo>
                  <a:pt x="10800" y="21309"/>
                </a:lnTo>
                <a:cubicBezTo>
                  <a:pt x="10800" y="21455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右大括号 68"/>
          <p:cNvSpPr/>
          <p:nvPr/>
        </p:nvSpPr>
        <p:spPr>
          <a:xfrm>
            <a:off x="3695760" y="4257720"/>
            <a:ext cx="142920" cy="250920"/>
          </a:xfrm>
          <a:custGeom>
            <a:avLst/>
            <a:gdLst>
              <a:gd name="textAreaLeft" fmla="*/ 0 w 142920"/>
              <a:gd name="textAreaRight" fmla="*/ 51480 w 142920"/>
              <a:gd name="textAreaTop" fmla="*/ 3600 h 250920"/>
              <a:gd name="textAreaBottom" fmla="*/ 247320 h 250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13"/>
                  <a:pt x="10800" y="1025"/>
                </a:cubicBezTo>
                <a:lnTo>
                  <a:pt x="10800" y="9775"/>
                </a:lnTo>
                <a:cubicBezTo>
                  <a:pt x="10800" y="10288"/>
                  <a:pt x="16200" y="10800"/>
                  <a:pt x="21600" y="10800"/>
                </a:cubicBezTo>
                <a:cubicBezTo>
                  <a:pt x="16200" y="10800"/>
                  <a:pt x="10800" y="11313"/>
                  <a:pt x="10800" y="11825"/>
                </a:cubicBezTo>
                <a:lnTo>
                  <a:pt x="10800" y="20575"/>
                </a:lnTo>
                <a:cubicBezTo>
                  <a:pt x="10800" y="21088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右大括号 69"/>
          <p:cNvSpPr/>
          <p:nvPr/>
        </p:nvSpPr>
        <p:spPr>
          <a:xfrm>
            <a:off x="3689280" y="4557600"/>
            <a:ext cx="142920" cy="1260720"/>
          </a:xfrm>
          <a:custGeom>
            <a:avLst/>
            <a:gdLst>
              <a:gd name="textAreaLeft" fmla="*/ 0 w 142920"/>
              <a:gd name="textAreaRight" fmla="*/ 51480 w 142920"/>
              <a:gd name="textAreaTop" fmla="*/ 3600 h 1260720"/>
              <a:gd name="textAreaBottom" fmla="*/ 1257120 h 12607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02"/>
                  <a:pt x="10800" y="204"/>
                </a:cubicBezTo>
                <a:lnTo>
                  <a:pt x="10800" y="10596"/>
                </a:lnTo>
                <a:cubicBezTo>
                  <a:pt x="10800" y="10698"/>
                  <a:pt x="16200" y="10800"/>
                  <a:pt x="21600" y="10800"/>
                </a:cubicBezTo>
                <a:cubicBezTo>
                  <a:pt x="16200" y="10800"/>
                  <a:pt x="10800" y="10902"/>
                  <a:pt x="10800" y="11004"/>
                </a:cubicBezTo>
                <a:lnTo>
                  <a:pt x="10800" y="21396"/>
                </a:lnTo>
                <a:cubicBezTo>
                  <a:pt x="10800" y="21498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右大括号 70"/>
          <p:cNvSpPr/>
          <p:nvPr/>
        </p:nvSpPr>
        <p:spPr>
          <a:xfrm>
            <a:off x="3697200" y="5932440"/>
            <a:ext cx="142920" cy="1674720"/>
          </a:xfrm>
          <a:custGeom>
            <a:avLst/>
            <a:gdLst>
              <a:gd name="textAreaLeft" fmla="*/ 0 w 142920"/>
              <a:gd name="textAreaRight" fmla="*/ 51480 w 142920"/>
              <a:gd name="textAreaTop" fmla="*/ 3600 h 1674720"/>
              <a:gd name="textAreaBottom" fmla="*/ 1671120 h 16747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7"/>
                  <a:pt x="10800" y="154"/>
                </a:cubicBezTo>
                <a:lnTo>
                  <a:pt x="10800" y="10646"/>
                </a:lnTo>
                <a:cubicBezTo>
                  <a:pt x="10800" y="10723"/>
                  <a:pt x="16200" y="10800"/>
                  <a:pt x="21600" y="10800"/>
                </a:cubicBezTo>
                <a:cubicBezTo>
                  <a:pt x="16200" y="10800"/>
                  <a:pt x="10800" y="10877"/>
                  <a:pt x="10800" y="10954"/>
                </a:cubicBezTo>
                <a:lnTo>
                  <a:pt x="10800" y="21446"/>
                </a:lnTo>
                <a:cubicBezTo>
                  <a:pt x="10800" y="21523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5" name="Picture 84" descr="F:\油料所工作\bar.tif"/>
          <p:cNvPicPr/>
          <p:nvPr/>
        </p:nvPicPr>
        <p:blipFill>
          <a:blip r:embed="rId6"/>
          <a:srcRect l="0" t="0" r="0" b="41333"/>
          <a:stretch/>
        </p:blipFill>
        <p:spPr>
          <a:xfrm>
            <a:off x="1935000" y="7689960"/>
            <a:ext cx="898560" cy="95040"/>
          </a:xfrm>
          <a:prstGeom prst="rect">
            <a:avLst/>
          </a:prstGeom>
          <a:ln w="0">
            <a:noFill/>
          </a:ln>
        </p:spPr>
      </p:pic>
      <p:sp>
        <p:nvSpPr>
          <p:cNvPr id="116" name="TextBox 78"/>
          <p:cNvSpPr/>
          <p:nvPr/>
        </p:nvSpPr>
        <p:spPr>
          <a:xfrm>
            <a:off x="1870200" y="7737480"/>
            <a:ext cx="48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Ma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79"/>
          <p:cNvSpPr/>
          <p:nvPr/>
        </p:nvSpPr>
        <p:spPr>
          <a:xfrm>
            <a:off x="2536920" y="7737480"/>
            <a:ext cx="487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M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矩形 1"/>
          <p:cNvSpPr/>
          <p:nvPr/>
        </p:nvSpPr>
        <p:spPr>
          <a:xfrm>
            <a:off x="392040" y="7924680"/>
            <a:ext cx="5924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5. Expression profiles of sucrose synthesis and transport genes i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WT. SS, sucrose synthase; SUT, sucrose transport protein; STP; sugar transporter protein; ERD, early response to dehydration transporters; SWEET, Sugars Will Eventually be Exported Transporter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19T23:39:19Z</dcterms:created>
  <dc:creator>万丽云</dc:creator>
  <dc:description/>
  <dc:language>en-US</dc:language>
  <cp:lastModifiedBy>wly</cp:lastModifiedBy>
  <dcterms:modified xsi:type="dcterms:W3CDTF">2019-07-10T01:22:34Z</dcterms:modified>
  <cp:revision>18</cp:revision>
  <dc:subject/>
  <dc:title>幻灯片 1</dc:title>
</cp:coreProperties>
</file>